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77" r:id="rId3"/>
    <p:sldId id="278" r:id="rId4"/>
    <p:sldId id="276" r:id="rId5"/>
    <p:sldId id="275" r:id="rId6"/>
    <p:sldId id="279" r:id="rId7"/>
    <p:sldId id="281" r:id="rId8"/>
    <p:sldId id="280" r:id="rId9"/>
    <p:sldId id="282" r:id="rId10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66" d="100"/>
          <a:sy n="66" d="100"/>
        </p:scale>
        <p:origin x="706" y="-365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DBCC1-CAAB-4248-B591-18B8592AF475}" type="datetimeFigureOut">
              <a:rPr lang="en-IE" smtClean="0"/>
              <a:t>19/02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600086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DBCC1-CAAB-4248-B591-18B8592AF475}" type="datetimeFigureOut">
              <a:rPr lang="en-IE" smtClean="0"/>
              <a:t>19/02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7934624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DBCC1-CAAB-4248-B591-18B8592AF475}" type="datetimeFigureOut">
              <a:rPr lang="en-IE" smtClean="0"/>
              <a:t>19/02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29738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DBCC1-CAAB-4248-B591-18B8592AF475}" type="datetimeFigureOut">
              <a:rPr lang="en-IE" smtClean="0"/>
              <a:t>19/02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925682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DBCC1-CAAB-4248-B591-18B8592AF475}" type="datetimeFigureOut">
              <a:rPr lang="en-IE" smtClean="0"/>
              <a:t>19/02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8048544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DBCC1-CAAB-4248-B591-18B8592AF475}" type="datetimeFigureOut">
              <a:rPr lang="en-IE" smtClean="0"/>
              <a:t>19/02/2022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430055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DBCC1-CAAB-4248-B591-18B8592AF475}" type="datetimeFigureOut">
              <a:rPr lang="en-IE" smtClean="0"/>
              <a:t>19/02/2022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7098313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DBCC1-CAAB-4248-B591-18B8592AF475}" type="datetimeFigureOut">
              <a:rPr lang="en-IE" smtClean="0"/>
              <a:t>19/02/2022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1632659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DBCC1-CAAB-4248-B591-18B8592AF475}" type="datetimeFigureOut">
              <a:rPr lang="en-IE" smtClean="0"/>
              <a:t>19/02/2022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900823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DBCC1-CAAB-4248-B591-18B8592AF475}" type="datetimeFigureOut">
              <a:rPr lang="en-IE" smtClean="0"/>
              <a:t>19/02/2022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889714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DBCC1-CAAB-4248-B591-18B8592AF475}" type="datetimeFigureOut">
              <a:rPr lang="en-IE" smtClean="0"/>
              <a:t>19/02/2022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749187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3DBCC1-CAAB-4248-B591-18B8592AF475}" type="datetimeFigureOut">
              <a:rPr lang="en-IE" smtClean="0"/>
              <a:t>19/02/2022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2DE1AD-E99F-49BD-B6F6-8CD8A40DEDA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4463142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7" Type="http://schemas.openxmlformats.org/officeDocument/2006/relationships/image" Target="../media/image14.tiff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tiff"/><Relationship Id="rId5" Type="http://schemas.openxmlformats.org/officeDocument/2006/relationships/image" Target="../media/image12.jpeg"/><Relationship Id="rId4" Type="http://schemas.openxmlformats.org/officeDocument/2006/relationships/image" Target="../media/image11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7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f"/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0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hyperlink" Target="http://genome.ucsc.edu/" TargetMode="Externa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f"/><Relationship Id="rId2" Type="http://schemas.openxmlformats.org/officeDocument/2006/relationships/image" Target="../media/image27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8640" y="231830"/>
            <a:ext cx="3598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Supplemental Figure S1 – Cruz et al.</a:t>
            </a:r>
          </a:p>
        </p:txBody>
      </p:sp>
      <p:sp>
        <p:nvSpPr>
          <p:cNvPr id="4" name="Rectangle 3"/>
          <p:cNvSpPr/>
          <p:nvPr/>
        </p:nvSpPr>
        <p:spPr>
          <a:xfrm>
            <a:off x="188640" y="5625841"/>
            <a:ext cx="634325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  <a:spcAft>
                <a:spcPts val="0"/>
              </a:spcAft>
            </a:pPr>
            <a:r>
              <a:rPr lang="en-IE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S1: HER2 expression in breast cancer cell lines. 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50,000 MCF7, MCF7-HER2 or SKBR3 cells were plated per well in 6-well plates and whole cell lysates prepared at </a:t>
            </a:r>
            <a:r>
              <a:rPr lang="en-I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fluency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or analysis by Western immunoblotting. Representative western blot images and </a:t>
            </a:r>
            <a:r>
              <a:rPr lang="en-I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nsitometric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alysis of three independent experiments confirmed that MCF7-HER2 and SKBR3 cells had higher HER2 protein expression than MCF7 control cells. JAM-A was robustly expressed in all three cell lines, with the highest expression in MCF7 cells. Results were compared using two-tailed, equal variance Student’s t-tests, ** p&lt;0.01, *** p&lt;0.001.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2983" y="2176978"/>
            <a:ext cx="4053840" cy="3334512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4083" y="601162"/>
            <a:ext cx="1691640" cy="15758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74768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8640" y="231830"/>
            <a:ext cx="3598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Supplemental Figure S2 – Cruz et al.</a:t>
            </a:r>
          </a:p>
        </p:txBody>
      </p:sp>
      <p:pic>
        <p:nvPicPr>
          <p:cNvPr id="4" name="Picture 3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106" t="11029"/>
          <a:stretch/>
        </p:blipFill>
        <p:spPr bwMode="auto">
          <a:xfrm>
            <a:off x="7600195" y="1123238"/>
            <a:ext cx="3437965" cy="2604437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Rectangle 4"/>
          <p:cNvSpPr/>
          <p:nvPr/>
        </p:nvSpPr>
        <p:spPr>
          <a:xfrm>
            <a:off x="116632" y="3568005"/>
            <a:ext cx="6552728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  <a:spcAft>
                <a:spcPts val="0"/>
              </a:spcAft>
            </a:pPr>
            <a:r>
              <a:rPr lang="en-IE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S2: JAM-A silencing using individual siRNA constructs reduces HER2 protein expression.</a:t>
            </a:r>
            <a:r>
              <a:rPr lang="en-IE" sz="12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50,000</a:t>
            </a:r>
            <a:r>
              <a:rPr lang="en-IE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CF7-HER2 cells were plated in 6-well plates, transfected 24 h later with 25 </a:t>
            </a:r>
            <a:r>
              <a:rPr lang="en-I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M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ontrol siRNA (</a:t>
            </a:r>
            <a:r>
              <a:rPr lang="en-I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NEG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or JAM-A siRNA (siJAM1 or siJAM2) and harvested 72 h later for immunoblot analysis. Representative blots and </a:t>
            </a:r>
            <a:r>
              <a:rPr lang="en-I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nsitometric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alysis of three independent experiments revealed that JAM-A silencing with either siJAM1 or siJAM2 exerted similar reductions in HER2 protein expression. Data represent mean ± </a:t>
            </a:r>
            <a:r>
              <a:rPr lang="en-I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e.m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compared using two-tailed, equal variance Student’s t-tests, ** p&lt;0.01, *** p&lt;0.001.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1562" y="1033201"/>
            <a:ext cx="4184998" cy="2357593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57" y="862813"/>
            <a:ext cx="2583172" cy="24435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3732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8640" y="231830"/>
            <a:ext cx="3598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Supplemental Figure S3 – Cruz et al.</a:t>
            </a:r>
          </a:p>
        </p:txBody>
      </p:sp>
      <p:sp>
        <p:nvSpPr>
          <p:cNvPr id="5" name="Rectangle 4"/>
          <p:cNvSpPr/>
          <p:nvPr/>
        </p:nvSpPr>
        <p:spPr>
          <a:xfrm>
            <a:off x="74171" y="6035232"/>
            <a:ext cx="6552728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1200"/>
              </a:spcBef>
              <a:spcAft>
                <a:spcPts val="0"/>
              </a:spcAft>
            </a:pPr>
            <a:r>
              <a:rPr lang="en-IE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S3: JAM-A overexpression upregulates HER2 protein expression in HER2-negative cell lines.</a:t>
            </a:r>
            <a:r>
              <a:rPr lang="en-IE" sz="12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CF7 </a:t>
            </a:r>
            <a:r>
              <a:rPr lang="en-IE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 MDA-MB-231 </a:t>
            </a:r>
            <a:r>
              <a:rPr lang="en-IE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s expressing either a pcDNA3 empty vector (EV) or full-length human JAM-A (</a:t>
            </a:r>
            <a:r>
              <a:rPr lang="en-I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T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were grown to confluence and subjected to </a:t>
            </a:r>
            <a:r>
              <a:rPr lang="en-I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DS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PAGE and Western blot analysis to compare JAM-A and HER2 protein expression. As shown in one of three representative experiments, HER2 protein expression was increased in JAM-A overexpressing cells relative to empty vector controls. </a:t>
            </a:r>
            <a:r>
              <a:rPr lang="en-I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nsitometric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quantification of two blots per protein (relative to actin expression) is shown to the right of each image. Since HER2 was undetectable in EV-expressing MCF7 cells, it was not possible to generate a </a:t>
            </a:r>
            <a:r>
              <a:rPr lang="en-I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nsitometric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raph comparing HER2 expression against that in </a:t>
            </a:r>
            <a:r>
              <a:rPr lang="en-I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T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JAM-A-overexpressing cells.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685" t="50403" r="10307" b="19579"/>
          <a:stretch/>
        </p:blipFill>
        <p:spPr bwMode="auto">
          <a:xfrm>
            <a:off x="723568" y="4168458"/>
            <a:ext cx="1776016" cy="117481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3" name="Group 2"/>
          <p:cNvGrpSpPr/>
          <p:nvPr/>
        </p:nvGrpSpPr>
        <p:grpSpPr>
          <a:xfrm>
            <a:off x="747480" y="1683675"/>
            <a:ext cx="1728192" cy="952529"/>
            <a:chOff x="980728" y="1462991"/>
            <a:chExt cx="1728192" cy="952529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26" t="49597" r="63594" b="32985"/>
            <a:stretch/>
          </p:blipFill>
          <p:spPr bwMode="auto">
            <a:xfrm>
              <a:off x="980728" y="1462991"/>
              <a:ext cx="1728192" cy="6816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26" t="73501" r="63594" b="19579"/>
            <a:stretch/>
          </p:blipFill>
          <p:spPr bwMode="auto">
            <a:xfrm>
              <a:off x="980728" y="2144688"/>
              <a:ext cx="1728192" cy="27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9" name="TextBox 8"/>
          <p:cNvSpPr txBox="1"/>
          <p:nvPr/>
        </p:nvSpPr>
        <p:spPr>
          <a:xfrm>
            <a:off x="232477" y="992560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/>
              <a:t>A)</a:t>
            </a:r>
            <a:endParaRPr lang="en-US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232477" y="3678531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/>
              <a:t>B)</a:t>
            </a:r>
            <a:endParaRPr lang="en-US" sz="1400" b="1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/>
          <a:srcRect t="12814"/>
          <a:stretch/>
        </p:blipFill>
        <p:spPr>
          <a:xfrm>
            <a:off x="3083034" y="3801847"/>
            <a:ext cx="2895600" cy="1908037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4"/>
          <a:srcRect t="20506"/>
          <a:stretch/>
        </p:blipFill>
        <p:spPr>
          <a:xfrm>
            <a:off x="3326874" y="1108363"/>
            <a:ext cx="2407920" cy="21031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28001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8640" y="231830"/>
            <a:ext cx="3598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Supplemental Figure S4 – Cruz et al.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88640" y="776536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/>
              <a:t>A)</a:t>
            </a:r>
            <a:endParaRPr lang="en-US" sz="1400" b="1" dirty="0"/>
          </a:p>
        </p:txBody>
      </p:sp>
      <p:sp>
        <p:nvSpPr>
          <p:cNvPr id="3" name="Rectangle 2"/>
          <p:cNvSpPr/>
          <p:nvPr/>
        </p:nvSpPr>
        <p:spPr>
          <a:xfrm>
            <a:off x="192634" y="7590793"/>
            <a:ext cx="6329459" cy="22467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IE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S4: JAM-A overexpression increases cell survival in HER2-negative breast cancer cell lines.  (A) </a:t>
            </a:r>
            <a:r>
              <a:rPr lang="en-I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50,000 MCF7 or MDA-MB-231 breast cancer cells overexpressing JAM-A or empty vector control were plated in 6-well plates and whole cell lysates prepared at </a:t>
            </a:r>
            <a:r>
              <a:rPr lang="en-IE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nfluency</a:t>
            </a:r>
            <a:r>
              <a:rPr lang="en-I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or Western immunoblotting. Representative western blot images and </a:t>
            </a:r>
            <a:r>
              <a:rPr lang="en-IE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nsitometric</a:t>
            </a:r>
            <a:r>
              <a:rPr lang="en-I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alysis for JAM-A protein expression normalised to actin, </a:t>
            </a:r>
            <a:r>
              <a:rPr lang="en-IE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KT</a:t>
            </a:r>
            <a:r>
              <a:rPr lang="en-I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rotein expression normalised to total </a:t>
            </a:r>
            <a:r>
              <a:rPr lang="en-IE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KT</a:t>
            </a:r>
            <a:r>
              <a:rPr lang="en-I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IE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RK</a:t>
            </a:r>
            <a:r>
              <a:rPr lang="en-I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xpression normalised to total </a:t>
            </a:r>
            <a:r>
              <a:rPr lang="en-IE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K</a:t>
            </a:r>
            <a:r>
              <a:rPr lang="en-I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MDA-MB-231 empty vector control and JAM-A-overexpressing cells and MCF7 empty vector control and JAM-A-overexpressing cells. Results revealed increased phosphorylation of </a:t>
            </a:r>
            <a:r>
              <a:rPr lang="en-IE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KT</a:t>
            </a:r>
            <a:r>
              <a:rPr lang="en-I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IE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K</a:t>
            </a:r>
            <a:r>
              <a:rPr lang="en-I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MDA-MB-231-JAM+ and MCF7-JAM+ cells compared to controls. Experiments were performed three times and data represent mean ± </a:t>
            </a:r>
            <a:r>
              <a:rPr lang="en-IE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e.m</a:t>
            </a:r>
            <a:r>
              <a:rPr lang="en-I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Results were compared using two-tailed, equal variance Student’s t-tests, ** p&lt;0.01, *** p&lt;0.001. </a:t>
            </a:r>
            <a:r>
              <a:rPr lang="en-IE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 </a:t>
            </a:r>
            <a:r>
              <a:rPr lang="en-I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,500 MCF7 or MDA-MB-231 cells overexpressing JAM-A or empty vector control were seeded in 96 well-plates and cell viability measured by </a:t>
            </a:r>
            <a:r>
              <a:rPr lang="en-IE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TT</a:t>
            </a:r>
            <a:r>
              <a:rPr lang="en-IE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ssays at 24 h to 120 h. MDA-MB-231-JAM+ and MCF7-JAM+ cells proliferated more than empty vector control cells. Experiments were performed three times and data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 mean ± </a:t>
            </a:r>
            <a:r>
              <a:rPr lang="en-US" sz="1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e.m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compared using two-tailed, equal variance Student’s t-tests, *p&lt;0,05, ** p&lt;0.01, *** p&lt;0.001. </a:t>
            </a:r>
            <a:endParaRPr lang="en-US" sz="10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0415" y="982670"/>
            <a:ext cx="3261499" cy="2010433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0415" y="3389950"/>
            <a:ext cx="3400958" cy="1941576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235" y="5265370"/>
            <a:ext cx="3104693" cy="2164232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1874" y="5268574"/>
            <a:ext cx="3421532" cy="217932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2029" y="583266"/>
            <a:ext cx="1612392" cy="217932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2029" y="2717866"/>
            <a:ext cx="2045208" cy="2432304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88640" y="5115560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/>
              <a:t>B)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9567118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8640" y="231830"/>
            <a:ext cx="3598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Supplemental Figure S5 – Cruz et al.</a:t>
            </a:r>
          </a:p>
        </p:txBody>
      </p:sp>
      <p:sp>
        <p:nvSpPr>
          <p:cNvPr id="5" name="Rectangle 4"/>
          <p:cNvSpPr/>
          <p:nvPr/>
        </p:nvSpPr>
        <p:spPr>
          <a:xfrm>
            <a:off x="331923" y="3688214"/>
            <a:ext cx="6270421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IE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S5: Independent JAM-A siRNA constructs reduce cell viability and survival pathway </a:t>
            </a:r>
            <a:r>
              <a:rPr lang="en-IE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gnaling</a:t>
            </a:r>
            <a:r>
              <a:rPr lang="en-IE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HER2-negative cells.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CF7 cells were transfected with 25nM control siRNA (</a:t>
            </a:r>
            <a:r>
              <a:rPr lang="en-I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NEG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or two different JAM-A siRNAs (siJAM1 or siJAM2) and analysed 72 hours later. </a:t>
            </a:r>
            <a:r>
              <a:rPr lang="en-IE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)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JAM-A gene silencing revealed that siJAM1 and siJAM2 significantly reduced cell viability as measured by </a:t>
            </a:r>
            <a:r>
              <a:rPr lang="en-I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lamar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lue assays. </a:t>
            </a:r>
            <a:r>
              <a:rPr lang="en-IE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)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presentative western blot images and densitometry analysis for </a:t>
            </a:r>
            <a:r>
              <a:rPr lang="en-I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KT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</a:t>
            </a:r>
            <a:r>
              <a:rPr lang="en-I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RK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fter JAM-A knockdown showed reductions in both </a:t>
            </a:r>
            <a:r>
              <a:rPr lang="en-I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hospho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proteins following siJAM1 or siJAM2 exposure compared to control conditions. Experiments were performed three times and data represent mean ± </a:t>
            </a:r>
            <a:r>
              <a:rPr lang="en-IE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.e.m</a:t>
            </a:r>
            <a:r>
              <a:rPr lang="en-IE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results were compared using equal variance, unpaired Student’s t-tests, *p&lt;0.05, ** p&lt;0.01, *** p&lt;0.001.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24803"/>
            <a:ext cx="2449373" cy="208026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0834" y="1174611"/>
            <a:ext cx="2660599" cy="2082394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7578" y="813757"/>
            <a:ext cx="1844376" cy="2769133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88640" y="761469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/>
              <a:t>A)</a:t>
            </a:r>
            <a:endParaRPr lang="en-US" sz="1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2399205" y="761469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/>
              <a:t>B)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4833099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8640" y="231830"/>
            <a:ext cx="3598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b="1" dirty="0"/>
              <a:t>Supplemental Figure S6 – Cruz et al.</a:t>
            </a:r>
          </a:p>
        </p:txBody>
      </p:sp>
      <p:sp>
        <p:nvSpPr>
          <p:cNvPr id="5" name="Rectangle 4"/>
          <p:cNvSpPr/>
          <p:nvPr/>
        </p:nvSpPr>
        <p:spPr>
          <a:xfrm>
            <a:off x="299466" y="6959854"/>
            <a:ext cx="6270421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IE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S6: High mean expression of JAM-A, HER2 and FOXA1 correlates with poorer overall survival in HER2-positive but not HER2-negative gastric cancer patient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ean combined mRNA expression of the JAM-A (F11r), HER2 (ERBB2) and FOXA1 genes in gastric cancer patients was correlated with overall survival (OS) using the online resource kmplot.com (Szasz AM et al,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Oncotarge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2016, 7,</a:t>
            </a:r>
            <a:r>
              <a:rPr lang="zh-CN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9322-49333; accessed on 8 December 2021), using only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JetSe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robes. The cutoff between high versus low expression was auto-selected by the online tool. There was a significant positive correlation between high mean expression of the three genes and poorer OS in HER2-positive gastric cancer patients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A);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edian survival 20.03 versus 23.6 months for patients with high versus low expression respectively) and the entire gastric cancer patient population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edian survival 22 versus 34.37 months for patients with high versus low expression respectively).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contrast, there was a trend towards a negative correlation between high mean expression of JAM-A, HER2 and FOXA1 (combined) and poorer OS in HER2-negative patients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B);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edian survival 40.7 versus 28.8 months for patients with high versus low expression respectively).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188640" y="1116831"/>
            <a:ext cx="2521415" cy="307777"/>
            <a:chOff x="188640" y="776536"/>
            <a:chExt cx="2521415" cy="307777"/>
          </a:xfrm>
        </p:grpSpPr>
        <p:sp>
          <p:nvSpPr>
            <p:cNvPr id="6" name="TextBox 5"/>
            <p:cNvSpPr txBox="1"/>
            <p:nvPr/>
          </p:nvSpPr>
          <p:spPr>
            <a:xfrm>
              <a:off x="188640" y="776536"/>
              <a:ext cx="34977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sz="1400" b="1" dirty="0"/>
                <a:t>A)</a:t>
              </a:r>
              <a:endParaRPr lang="en-US" sz="1400" b="1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41860" y="827839"/>
              <a:ext cx="206819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ER2-positive gastric cancer patients: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3494530" y="1116831"/>
            <a:ext cx="2682932" cy="307777"/>
            <a:chOff x="3494530" y="926920"/>
            <a:chExt cx="2682932" cy="307777"/>
          </a:xfrm>
        </p:grpSpPr>
        <p:sp>
          <p:nvSpPr>
            <p:cNvPr id="8" name="TextBox 7"/>
            <p:cNvSpPr txBox="1"/>
            <p:nvPr/>
          </p:nvSpPr>
          <p:spPr>
            <a:xfrm>
              <a:off x="3494530" y="926920"/>
              <a:ext cx="3417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sz="1400" b="1" dirty="0"/>
                <a:t>B)</a:t>
              </a:r>
              <a:endParaRPr lang="en-US" sz="1400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080413" y="988988"/>
              <a:ext cx="20970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ER2-negative gastric cancer patients: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2172295" y="3924686"/>
            <a:ext cx="1988018" cy="317649"/>
            <a:chOff x="203068" y="3853135"/>
            <a:chExt cx="1988018" cy="317649"/>
          </a:xfrm>
        </p:grpSpPr>
        <p:sp>
          <p:nvSpPr>
            <p:cNvPr id="7" name="TextBox 6"/>
            <p:cNvSpPr txBox="1"/>
            <p:nvPr/>
          </p:nvSpPr>
          <p:spPr>
            <a:xfrm>
              <a:off x="203068" y="3853135"/>
              <a:ext cx="33534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sz="1400" b="1" dirty="0"/>
                <a:t>C)</a:t>
              </a:r>
              <a:endParaRPr lang="en-US" sz="140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88752" y="3955340"/>
              <a:ext cx="15023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ll gastric cancer patients: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4" name="Picture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0720" y="4242335"/>
            <a:ext cx="2438400" cy="24384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129" y="1464729"/>
            <a:ext cx="2438400" cy="243840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8912" y="1464729"/>
            <a:ext cx="2438400" cy="2438400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 rot="16200000">
            <a:off x="-165844" y="2389725"/>
            <a:ext cx="9076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/>
              <a:t>Overall survival</a:t>
            </a:r>
            <a:endParaRPr lang="en-US" sz="900" dirty="0"/>
          </a:p>
        </p:txBody>
      </p:sp>
      <p:sp>
        <p:nvSpPr>
          <p:cNvPr id="19" name="TextBox 18"/>
          <p:cNvSpPr txBox="1"/>
          <p:nvPr/>
        </p:nvSpPr>
        <p:spPr>
          <a:xfrm rot="16200000">
            <a:off x="3308369" y="2389726"/>
            <a:ext cx="9076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/>
              <a:t>Overall survival</a:t>
            </a:r>
            <a:endParaRPr lang="en-US" sz="900" dirty="0"/>
          </a:p>
        </p:txBody>
      </p:sp>
      <p:sp>
        <p:nvSpPr>
          <p:cNvPr id="20" name="TextBox 19"/>
          <p:cNvSpPr txBox="1"/>
          <p:nvPr/>
        </p:nvSpPr>
        <p:spPr>
          <a:xfrm rot="16200000">
            <a:off x="1584236" y="5191541"/>
            <a:ext cx="9076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/>
              <a:t>Overall survival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40196598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8640" y="231830"/>
            <a:ext cx="3598549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IE" b="1" dirty="0"/>
              <a:t>Supplemental Figure S7 – Cruz et al.</a:t>
            </a:r>
          </a:p>
        </p:txBody>
      </p:sp>
      <p:sp>
        <p:nvSpPr>
          <p:cNvPr id="5" name="Rectangle 4"/>
          <p:cNvSpPr/>
          <p:nvPr/>
        </p:nvSpPr>
        <p:spPr>
          <a:xfrm>
            <a:off x="299466" y="7844521"/>
            <a:ext cx="6270421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IE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S7: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ZONAB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silencing in SK-BR-3 cells had no effect on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ZONAB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protein expression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K-BR-3 cells were plated at 150,000 cells per well in 6- well plates and transfected after 24 h with 25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control siRNA o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ZONA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iRNA, and repeated every 72 h. Protein was extracted at 6 days, 8 days or 10 days for Western blot analysis. Representative western blot images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ensitometri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alysis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ZONA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rotein expressio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ormalis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evealed that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ZONA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ilencing had no significant effect o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ZONA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protein expression. Experiments were performed three times and data represent mean ±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.e.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compared using two-tailed, equal variance Student’s t-tests.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7519" y="1248927"/>
            <a:ext cx="3254315" cy="158307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2224" y="3736538"/>
            <a:ext cx="4184904" cy="32034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69816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8640" y="231830"/>
            <a:ext cx="3598549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IE" b="1" dirty="0"/>
              <a:t>Supplemental Figure S8 – Cruz et al.</a:t>
            </a:r>
          </a:p>
        </p:txBody>
      </p:sp>
      <p:sp>
        <p:nvSpPr>
          <p:cNvPr id="5" name="Rectangle 4"/>
          <p:cNvSpPr/>
          <p:nvPr/>
        </p:nvSpPr>
        <p:spPr>
          <a:xfrm>
            <a:off x="299466" y="7242942"/>
            <a:ext cx="6270421" cy="2308324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pPr algn="just"/>
            <a:r>
              <a:rPr lang="en-IE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 Figure S8: </a:t>
            </a:r>
            <a:r>
              <a:rPr lang="en-IE" sz="12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hIP-seq</a:t>
            </a:r>
            <a:r>
              <a:rPr lang="en-IE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inding sites for FOXA1 from the ENCODE project. </a:t>
            </a:r>
            <a:r>
              <a:rPr lang="en-IE" sz="1200" dirty="0">
                <a:latin typeface="Arial" panose="020B0604020202020204" pitchFamily="34" charset="0"/>
                <a:cs typeface="Arial" panose="020B0604020202020204" pitchFamily="34" charset="0"/>
              </a:rPr>
              <a:t>A screenshot from </a:t>
            </a:r>
            <a:r>
              <a:rPr lang="en-IE" sz="1200" dirty="0">
                <a:latin typeface="Arial" panose="020B0604020202020204" pitchFamily="34" charset="0"/>
                <a:cs typeface="Arial" panose="020B0604020202020204" pitchFamily="34" charset="0"/>
                <a:hlinkClick r:id="rId2"/>
              </a:rPr>
              <a:t>http://genome.ucsc.edu/</a:t>
            </a:r>
            <a:r>
              <a:rPr lang="en-IE" sz="1200" dirty="0">
                <a:latin typeface="Arial" panose="020B0604020202020204" pitchFamily="34" charset="0"/>
                <a:cs typeface="Arial" panose="020B0604020202020204" pitchFamily="34" charset="0"/>
              </a:rPr>
              <a:t> shows details of the </a:t>
            </a:r>
            <a:r>
              <a:rPr lang="en-IE" sz="1200" dirty="0" err="1">
                <a:latin typeface="Arial" panose="020B0604020202020204" pitchFamily="34" charset="0"/>
                <a:cs typeface="Arial" panose="020B0604020202020204" pitchFamily="34" charset="0"/>
              </a:rPr>
              <a:t>ChIP-seq</a:t>
            </a:r>
            <a:r>
              <a:rPr lang="en-IE" sz="1200" dirty="0">
                <a:latin typeface="Arial" panose="020B0604020202020204" pitchFamily="34" charset="0"/>
                <a:cs typeface="Arial" panose="020B0604020202020204" pitchFamily="34" charset="0"/>
              </a:rPr>
              <a:t> binding site for FOXA1 from the ENCODE project in the proximal promoter of HER2 (chr17:37,844,393-37,884,915) 1,237bp upstream from the transcription start site. </a:t>
            </a:r>
            <a:r>
              <a:rPr lang="en-IE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IE" sz="1200" dirty="0">
                <a:latin typeface="Arial" panose="020B0604020202020204" pitchFamily="34" charset="0"/>
                <a:cs typeface="Arial" panose="020B0604020202020204" pitchFamily="34" charset="0"/>
              </a:rPr>
              <a:t> The exact location of the </a:t>
            </a:r>
            <a:r>
              <a:rPr lang="en-IE" sz="1200" dirty="0" err="1">
                <a:latin typeface="Arial" panose="020B0604020202020204" pitchFamily="34" charset="0"/>
                <a:cs typeface="Arial" panose="020B0604020202020204" pitchFamily="34" charset="0"/>
              </a:rPr>
              <a:t>TFBS</a:t>
            </a:r>
            <a:r>
              <a:rPr lang="en-IE" sz="1200" dirty="0">
                <a:latin typeface="Arial" panose="020B0604020202020204" pitchFamily="34" charset="0"/>
                <a:cs typeface="Arial" panose="020B0604020202020204" pitchFamily="34" charset="0"/>
              </a:rPr>
              <a:t> motif (chr17:37,843,298-37,843,314) in the 304bp </a:t>
            </a:r>
            <a:r>
              <a:rPr lang="en-IE" sz="1200" dirty="0" err="1">
                <a:latin typeface="Arial" panose="020B0604020202020204" pitchFamily="34" charset="0"/>
                <a:cs typeface="Arial" panose="020B0604020202020204" pitchFamily="34" charset="0"/>
              </a:rPr>
              <a:t>ChIP-seq</a:t>
            </a:r>
            <a:r>
              <a:rPr lang="en-IE" sz="1200" dirty="0">
                <a:latin typeface="Arial" panose="020B0604020202020204" pitchFamily="34" charset="0"/>
                <a:cs typeface="Arial" panose="020B0604020202020204" pitchFamily="34" charset="0"/>
              </a:rPr>
              <a:t> region (chr17:37,843,156-37,843,459) is shown along with motif logo.</a:t>
            </a:r>
            <a:r>
              <a:rPr lang="en-IE" sz="1200" b="1" dirty="0">
                <a:latin typeface="Arial" panose="020B0604020202020204" pitchFamily="34" charset="0"/>
                <a:cs typeface="Arial" panose="020B0604020202020204" pitchFamily="34" charset="0"/>
              </a:rPr>
              <a:t> (B)</a:t>
            </a:r>
            <a:r>
              <a:rPr lang="en-IE" sz="1200" dirty="0">
                <a:latin typeface="Arial" panose="020B0604020202020204" pitchFamily="34" charset="0"/>
                <a:cs typeface="Arial" panose="020B0604020202020204" pitchFamily="34" charset="0"/>
              </a:rPr>
              <a:t> The exact location of the </a:t>
            </a:r>
            <a:r>
              <a:rPr lang="en-IE" sz="1200" dirty="0" err="1">
                <a:latin typeface="Arial" panose="020B0604020202020204" pitchFamily="34" charset="0"/>
                <a:cs typeface="Arial" panose="020B0604020202020204" pitchFamily="34" charset="0"/>
              </a:rPr>
              <a:t>TFBS</a:t>
            </a:r>
            <a:r>
              <a:rPr lang="en-IE" sz="1200" dirty="0">
                <a:latin typeface="Arial" panose="020B0604020202020204" pitchFamily="34" charset="0"/>
                <a:cs typeface="Arial" panose="020B0604020202020204" pitchFamily="34" charset="0"/>
              </a:rPr>
              <a:t> motif (chr17:37844536-37844552) in the 285bp </a:t>
            </a:r>
            <a:r>
              <a:rPr lang="en-IE" sz="1200" dirty="0" err="1">
                <a:latin typeface="Arial" panose="020B0604020202020204" pitchFamily="34" charset="0"/>
                <a:cs typeface="Arial" panose="020B0604020202020204" pitchFamily="34" charset="0"/>
              </a:rPr>
              <a:t>ChIP-seq</a:t>
            </a:r>
            <a:r>
              <a:rPr lang="en-IE" sz="1200" dirty="0">
                <a:latin typeface="Arial" panose="020B0604020202020204" pitchFamily="34" charset="0"/>
                <a:cs typeface="Arial" panose="020B0604020202020204" pitchFamily="34" charset="0"/>
              </a:rPr>
              <a:t> region (chr17:37,844,349-37,844,633) is shown along with motif logo.</a:t>
            </a:r>
            <a:r>
              <a:rPr lang="en-IE" sz="1200" b="1" dirty="0">
                <a:latin typeface="Arial" panose="020B0604020202020204" pitchFamily="34" charset="0"/>
                <a:cs typeface="Arial" panose="020B0604020202020204" pitchFamily="34" charset="0"/>
              </a:rPr>
              <a:t> (C) </a:t>
            </a:r>
            <a:r>
              <a:rPr lang="en-IE" sz="1200" dirty="0">
                <a:latin typeface="Arial" panose="020B0604020202020204" pitchFamily="34" charset="0"/>
                <a:cs typeface="Arial" panose="020B0604020202020204" pitchFamily="34" charset="0"/>
              </a:rPr>
              <a:t>The exact location of the </a:t>
            </a:r>
            <a:r>
              <a:rPr lang="en-IE" sz="1200" dirty="0" err="1">
                <a:latin typeface="Arial" panose="020B0604020202020204" pitchFamily="34" charset="0"/>
                <a:cs typeface="Arial" panose="020B0604020202020204" pitchFamily="34" charset="0"/>
              </a:rPr>
              <a:t>TFBS</a:t>
            </a:r>
            <a:r>
              <a:rPr lang="en-IE" sz="1200" dirty="0">
                <a:latin typeface="Arial" panose="020B0604020202020204" pitchFamily="34" charset="0"/>
                <a:cs typeface="Arial" panose="020B0604020202020204" pitchFamily="34" charset="0"/>
              </a:rPr>
              <a:t> motif (chr17:37,852,087-37,852,103) in the 331bp </a:t>
            </a:r>
            <a:r>
              <a:rPr lang="en-IE" sz="1200" dirty="0" err="1">
                <a:latin typeface="Arial" panose="020B0604020202020204" pitchFamily="34" charset="0"/>
                <a:cs typeface="Arial" panose="020B0604020202020204" pitchFamily="34" charset="0"/>
              </a:rPr>
              <a:t>ChIP-seq</a:t>
            </a:r>
            <a:r>
              <a:rPr lang="en-IE" sz="1200" dirty="0">
                <a:latin typeface="Arial" panose="020B0604020202020204" pitchFamily="34" charset="0"/>
                <a:cs typeface="Arial" panose="020B0604020202020204" pitchFamily="34" charset="0"/>
              </a:rPr>
              <a:t> region (chr17:37,851,885-37,852,215) is shown along with motif logo.</a:t>
            </a:r>
            <a:r>
              <a:rPr lang="en-IE" sz="1200" b="1" dirty="0">
                <a:latin typeface="Arial" panose="020B0604020202020204" pitchFamily="34" charset="0"/>
                <a:cs typeface="Arial" panose="020B0604020202020204" pitchFamily="34" charset="0"/>
              </a:rPr>
              <a:t> (D)</a:t>
            </a:r>
            <a:r>
              <a:rPr lang="en-IE" sz="1200" dirty="0">
                <a:latin typeface="Arial" panose="020B0604020202020204" pitchFamily="34" charset="0"/>
                <a:cs typeface="Arial" panose="020B0604020202020204" pitchFamily="34" charset="0"/>
              </a:rPr>
              <a:t> The exact location of the </a:t>
            </a:r>
            <a:r>
              <a:rPr lang="en-IE" sz="1200" dirty="0" err="1">
                <a:latin typeface="Arial" panose="020B0604020202020204" pitchFamily="34" charset="0"/>
                <a:cs typeface="Arial" panose="020B0604020202020204" pitchFamily="34" charset="0"/>
              </a:rPr>
              <a:t>TFBS</a:t>
            </a:r>
            <a:r>
              <a:rPr lang="en-IE" sz="1200" dirty="0">
                <a:latin typeface="Arial" panose="020B0604020202020204" pitchFamily="34" charset="0"/>
                <a:cs typeface="Arial" panose="020B0604020202020204" pitchFamily="34" charset="0"/>
              </a:rPr>
              <a:t> motif (chr17:37,859,747-37,859,763) in the 322bp </a:t>
            </a:r>
            <a:r>
              <a:rPr lang="en-IE" sz="1200" dirty="0" err="1">
                <a:latin typeface="Arial" panose="020B0604020202020204" pitchFamily="34" charset="0"/>
                <a:cs typeface="Arial" panose="020B0604020202020204" pitchFamily="34" charset="0"/>
              </a:rPr>
              <a:t>ChIP-seq</a:t>
            </a:r>
            <a:r>
              <a:rPr lang="en-IE" sz="1200" dirty="0">
                <a:latin typeface="Arial" panose="020B0604020202020204" pitchFamily="34" charset="0"/>
                <a:cs typeface="Arial" panose="020B0604020202020204" pitchFamily="34" charset="0"/>
              </a:rPr>
              <a:t> region (chr17:37,859,628-37,859,949) is shown along with motif logo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88640" y="649471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/>
              <a:t>A)</a:t>
            </a:r>
            <a:endParaRPr lang="en-US" sz="1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3494530" y="649471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/>
              <a:t>B)</a:t>
            </a:r>
            <a:endParaRPr lang="en-US" sz="1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36556" y="3862716"/>
            <a:ext cx="335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/>
              <a:t>C)</a:t>
            </a:r>
            <a:endParaRPr lang="en-US" sz="14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3658998" y="3862716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/>
              <a:t>D)</a:t>
            </a:r>
            <a:endParaRPr lang="en-US" sz="1400" b="1" dirty="0"/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308" y="893908"/>
            <a:ext cx="3264197" cy="2994125"/>
          </a:xfrm>
          <a:prstGeom prst="rect">
            <a:avLst/>
          </a:prstGeom>
          <a:noFill/>
          <a:ln>
            <a:noFill/>
          </a:ln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4054" y="893908"/>
            <a:ext cx="3283333" cy="2864091"/>
          </a:xfrm>
          <a:prstGeom prst="rect">
            <a:avLst/>
          </a:prstGeom>
          <a:noFill/>
          <a:ln>
            <a:noFill/>
          </a:ln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9053" y="4137391"/>
            <a:ext cx="3243333" cy="2843333"/>
          </a:xfrm>
          <a:prstGeom prst="rect">
            <a:avLst/>
          </a:prstGeom>
          <a:noFill/>
          <a:ln>
            <a:noFill/>
          </a:ln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2799" y="4137391"/>
            <a:ext cx="3203333" cy="2973333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407397323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8640" y="231830"/>
            <a:ext cx="3598549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IE" b="1" dirty="0"/>
              <a:t>Supplemental Figure S9 – Cruz et al.</a:t>
            </a:r>
          </a:p>
        </p:txBody>
      </p:sp>
      <p:sp>
        <p:nvSpPr>
          <p:cNvPr id="5" name="Rectangle 4"/>
          <p:cNvSpPr/>
          <p:nvPr/>
        </p:nvSpPr>
        <p:spPr>
          <a:xfrm>
            <a:off x="3617618" y="1084313"/>
            <a:ext cx="2952269" cy="39703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IE" sz="1200" b="1" dirty="0">
                <a:latin typeface="+mj-lt"/>
                <a:ea typeface="Calibri" panose="020F0502020204030204" pitchFamily="34" charset="0"/>
                <a:cs typeface="Arial" panose="020B0604020202020204" pitchFamily="34" charset="0"/>
              </a:rPr>
              <a:t>Supplemental Figure S9: </a:t>
            </a:r>
            <a:r>
              <a:rPr lang="en-US" sz="1200" b="1" dirty="0">
                <a:latin typeface="+mj-lt"/>
              </a:rPr>
              <a:t>High average gene expression of JAM-A, HER2 and FOXA1 correlates with poorer overall survival in HER2-positive but not HER2-negative breast cancer patients.</a:t>
            </a:r>
            <a:r>
              <a:rPr lang="en-US" sz="1200" dirty="0">
                <a:latin typeface="+mj-lt"/>
              </a:rPr>
              <a:t> Mean mRNA expression of the JAM-A (F11r), HER2 (ERBB2) and FOXA1 genes in breast cancer patients was correlated with overall survival (OS) in breast cancer patients using the online resource kmplot.com [31], (accessed on 8 December 2021) using only </a:t>
            </a:r>
            <a:r>
              <a:rPr lang="en-US" sz="1200" dirty="0" err="1">
                <a:latin typeface="+mj-lt"/>
              </a:rPr>
              <a:t>JetSet</a:t>
            </a:r>
            <a:r>
              <a:rPr lang="en-US" sz="1200" dirty="0">
                <a:latin typeface="+mj-lt"/>
              </a:rPr>
              <a:t> probes. The cutoff </a:t>
            </a:r>
            <a:r>
              <a:rPr lang="en-US" sz="1200" dirty="0" err="1">
                <a:latin typeface="+mj-lt"/>
              </a:rPr>
              <a:t>bewteen</a:t>
            </a:r>
            <a:r>
              <a:rPr lang="en-US" sz="1200" dirty="0">
                <a:latin typeface="+mj-lt"/>
              </a:rPr>
              <a:t> high and low expression was automatically selected by the online tool. There was a statistically-significant positive correlation between high mean expression of JAM-A, HER2 and FOXA1 and poorer OS in HER2-positive patients </a:t>
            </a:r>
            <a:r>
              <a:rPr lang="en-US" sz="1200" b="1" dirty="0">
                <a:latin typeface="+mj-lt"/>
              </a:rPr>
              <a:t>(A)</a:t>
            </a:r>
            <a:r>
              <a:rPr lang="en-US" sz="1200" dirty="0">
                <a:latin typeface="+mj-lt"/>
              </a:rPr>
              <a:t>, or all patients combined </a:t>
            </a:r>
            <a:r>
              <a:rPr lang="en-US" sz="1200" b="1" dirty="0">
                <a:latin typeface="+mj-lt"/>
              </a:rPr>
              <a:t>(C)</a:t>
            </a:r>
            <a:r>
              <a:rPr lang="en-US" sz="1200" dirty="0">
                <a:latin typeface="+mj-lt"/>
              </a:rPr>
              <a:t>, and a significant negative correlation between their high mean expression and poorer OS in HER2-negative patients </a:t>
            </a:r>
            <a:r>
              <a:rPr lang="en-US" sz="1200" b="1" dirty="0">
                <a:latin typeface="+mj-lt"/>
              </a:rPr>
              <a:t>(B)</a:t>
            </a:r>
            <a:r>
              <a:rPr lang="en-US" sz="1200" dirty="0">
                <a:latin typeface="+mj-lt"/>
              </a:rPr>
              <a:t>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88640" y="776536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/>
              <a:t>A)</a:t>
            </a:r>
            <a:endParaRPr lang="en-US" sz="1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203068" y="6850135"/>
            <a:ext cx="3353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/>
              <a:t>C)</a:t>
            </a:r>
            <a:endParaRPr lang="en-US" sz="1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196656" y="3802209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1400" b="1" dirty="0"/>
              <a:t>B)</a:t>
            </a:r>
            <a:endParaRPr lang="en-US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057388" y="812209"/>
            <a:ext cx="203934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b="1" dirty="0">
                <a:latin typeface="Arial" panose="020B0604020202020204" pitchFamily="34" charset="0"/>
                <a:cs typeface="Arial" panose="020B0604020202020204" pitchFamily="34" charset="0"/>
              </a:rPr>
              <a:t>HER2-positive breast cancer patients: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057388" y="3864277"/>
            <a:ext cx="20681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b="1" dirty="0">
                <a:latin typeface="Arial" panose="020B0604020202020204" pitchFamily="34" charset="0"/>
                <a:cs typeface="Arial" panose="020B0604020202020204" pitchFamily="34" charset="0"/>
              </a:rPr>
              <a:t>HER2-negative breast cancer patients: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057388" y="6898489"/>
            <a:ext cx="14734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800" b="1" dirty="0">
                <a:latin typeface="Arial" panose="020B0604020202020204" pitchFamily="34" charset="0"/>
                <a:cs typeface="Arial" panose="020B0604020202020204" pitchFamily="34" charset="0"/>
              </a:rPr>
              <a:t>All breast cancer patients: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200317" y="1964381"/>
            <a:ext cx="9156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/>
              <a:t>Overall Survival</a:t>
            </a:r>
            <a:endParaRPr lang="en-US" sz="900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204322" y="8082120"/>
            <a:ext cx="9076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/>
              <a:t>Overall survival</a:t>
            </a:r>
            <a:endParaRPr lang="en-US" sz="900" dirty="0"/>
          </a:p>
        </p:txBody>
      </p:sp>
      <p:sp>
        <p:nvSpPr>
          <p:cNvPr id="28" name="TextBox 27"/>
          <p:cNvSpPr txBox="1"/>
          <p:nvPr/>
        </p:nvSpPr>
        <p:spPr>
          <a:xfrm rot="16200000">
            <a:off x="204323" y="5071296"/>
            <a:ext cx="9076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E" sz="900" dirty="0"/>
              <a:t>Overall survival</a:t>
            </a:r>
            <a:endParaRPr lang="en-US" sz="900" dirty="0"/>
          </a:p>
        </p:txBody>
      </p:sp>
      <p:pic>
        <p:nvPicPr>
          <p:cNvPr id="32" name="Picture 3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8731" y="7113933"/>
            <a:ext cx="2438400" cy="2438400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8731" y="981530"/>
            <a:ext cx="2438400" cy="2438400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8731" y="4079721"/>
            <a:ext cx="2438400" cy="2438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8375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20</TotalTime>
  <Words>1521</Words>
  <Application>Microsoft Office PowerPoint</Application>
  <PresentationFormat>A4 Paper (210x297 mm)</PresentationFormat>
  <Paragraphs>46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宋体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 Hopkins</dc:creator>
  <cp:lastModifiedBy>MDPI</cp:lastModifiedBy>
  <cp:revision>157</cp:revision>
  <dcterms:created xsi:type="dcterms:W3CDTF">2018-10-03T10:36:24Z</dcterms:created>
  <dcterms:modified xsi:type="dcterms:W3CDTF">2022-02-19T11:38:24Z</dcterms:modified>
</cp:coreProperties>
</file>